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56" r:id="rId2"/>
    <p:sldId id="257" r:id="rId3"/>
    <p:sldId id="263" r:id="rId4"/>
    <p:sldId id="258" r:id="rId5"/>
    <p:sldId id="262" r:id="rId6"/>
    <p:sldId id="259" r:id="rId7"/>
    <p:sldId id="260" r:id="rId8"/>
  </p:sldIdLst>
  <p:sldSz cx="6858000" cy="9144000" type="screen4x3"/>
  <p:notesSz cx="6797675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924" y="21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52BDFA5-C8A0-425B-86C0-1F61B9359100}" type="datetimeFigureOut">
              <a:rPr lang="fr-FR" smtClean="0"/>
              <a:t>19/02/2015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E55E050-85CE-4223-8726-11B188D0550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618997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E55E050-85CE-4223-8726-11B188D05500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456014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51A7D5-8FA4-4252-8B6F-DB2F5D763031}" type="datetimeFigureOut">
              <a:rPr lang="fr-FR" smtClean="0"/>
              <a:t>19/02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C14B2-A3A9-46BC-94F8-5EE446681C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046725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51A7D5-8FA4-4252-8B6F-DB2F5D763031}" type="datetimeFigureOut">
              <a:rPr lang="fr-FR" smtClean="0"/>
              <a:t>19/02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C14B2-A3A9-46BC-94F8-5EE446681C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615746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51A7D5-8FA4-4252-8B6F-DB2F5D763031}" type="datetimeFigureOut">
              <a:rPr lang="fr-FR" smtClean="0"/>
              <a:t>19/02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C14B2-A3A9-46BC-94F8-5EE446681C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9306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51A7D5-8FA4-4252-8B6F-DB2F5D763031}" type="datetimeFigureOut">
              <a:rPr lang="fr-FR" smtClean="0"/>
              <a:t>19/02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C14B2-A3A9-46BC-94F8-5EE446681C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790681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51A7D5-8FA4-4252-8B6F-DB2F5D763031}" type="datetimeFigureOut">
              <a:rPr lang="fr-FR" smtClean="0"/>
              <a:t>19/02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C14B2-A3A9-46BC-94F8-5EE446681C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308598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51A7D5-8FA4-4252-8B6F-DB2F5D763031}" type="datetimeFigureOut">
              <a:rPr lang="fr-FR" smtClean="0"/>
              <a:t>19/02/20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C14B2-A3A9-46BC-94F8-5EE446681C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578956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51A7D5-8FA4-4252-8B6F-DB2F5D763031}" type="datetimeFigureOut">
              <a:rPr lang="fr-FR" smtClean="0"/>
              <a:t>19/02/2015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C14B2-A3A9-46BC-94F8-5EE446681C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983617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51A7D5-8FA4-4252-8B6F-DB2F5D763031}" type="datetimeFigureOut">
              <a:rPr lang="fr-FR" smtClean="0"/>
              <a:t>19/02/2015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C14B2-A3A9-46BC-94F8-5EE446681C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284551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51A7D5-8FA4-4252-8B6F-DB2F5D763031}" type="datetimeFigureOut">
              <a:rPr lang="fr-FR" smtClean="0"/>
              <a:t>19/02/2015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C14B2-A3A9-46BC-94F8-5EE446681C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079093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51A7D5-8FA4-4252-8B6F-DB2F5D763031}" type="datetimeFigureOut">
              <a:rPr lang="fr-FR" smtClean="0"/>
              <a:t>19/02/20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C14B2-A3A9-46BC-94F8-5EE446681C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87620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51A7D5-8FA4-4252-8B6F-DB2F5D763031}" type="datetimeFigureOut">
              <a:rPr lang="fr-FR" smtClean="0"/>
              <a:t>19/02/20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C14B2-A3A9-46BC-94F8-5EE446681C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591586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51A7D5-8FA4-4252-8B6F-DB2F5D763031}" type="datetimeFigureOut">
              <a:rPr lang="fr-FR" smtClean="0"/>
              <a:t>19/02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AC14B2-A3A9-46BC-94F8-5EE446681C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395540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emf"/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38962" y="611560"/>
            <a:ext cx="4380076" cy="306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38963" y="3167844"/>
            <a:ext cx="4380075" cy="306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38963" y="5724128"/>
            <a:ext cx="4380075" cy="306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ZoneTexte 6"/>
          <p:cNvSpPr txBox="1"/>
          <p:nvPr/>
        </p:nvSpPr>
        <p:spPr>
          <a:xfrm>
            <a:off x="303498" y="107504"/>
            <a:ext cx="625100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Partial restriction 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p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rganization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asmids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sed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is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udy</a:t>
            </a:r>
            <a:endParaRPr lang="fr-F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451636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22044" y="611560"/>
            <a:ext cx="4380075" cy="306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22044" y="3167844"/>
            <a:ext cx="4380075" cy="306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22044" y="5724128"/>
            <a:ext cx="4380075" cy="306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ZoneTexte 7"/>
          <p:cNvSpPr txBox="1"/>
          <p:nvPr/>
        </p:nvSpPr>
        <p:spPr>
          <a:xfrm>
            <a:off x="303498" y="107504"/>
            <a:ext cx="625100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Partial restriction 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p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rganization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asmids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sed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is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udy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inued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fr-F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790383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303498" y="107504"/>
            <a:ext cx="625100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Partial restriction 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p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rganization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asmids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sed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is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udy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inued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fr-F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0137" y="4500352"/>
            <a:ext cx="4637727" cy="324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0137" y="1115976"/>
            <a:ext cx="4637727" cy="324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632515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ZoneTexte 7"/>
          <p:cNvSpPr txBox="1"/>
          <p:nvPr/>
        </p:nvSpPr>
        <p:spPr>
          <a:xfrm>
            <a:off x="303498" y="107504"/>
            <a:ext cx="625100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Partial restriction 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p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rganization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asmids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sed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is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udy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inued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fr-F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38963" y="899992"/>
            <a:ext cx="4380075" cy="306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2486" y="4140352"/>
            <a:ext cx="5153029" cy="36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3451916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303498" y="107504"/>
            <a:ext cx="625100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Partial restriction 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p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rganization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asmids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sed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is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udy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inued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fr-F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7182" y="4427984"/>
            <a:ext cx="6183636" cy="43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7182" y="683568"/>
            <a:ext cx="6183636" cy="43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964565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303498" y="107504"/>
            <a:ext cx="625100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Partial restriction 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p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rganization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asmids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sed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is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udy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inued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fr-F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100" name="Picture 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7182" y="683568"/>
            <a:ext cx="6183636" cy="43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1" name="Picture 5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7182" y="4427984"/>
            <a:ext cx="6183636" cy="43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0966826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303498" y="107504"/>
            <a:ext cx="625100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Partial restriction 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p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rganization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asmids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sed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is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udy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fr-F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inued</a:t>
            </a:r>
            <a:r>
              <a:rPr lang="fr-F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fr-F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2485" y="927476"/>
            <a:ext cx="5153030" cy="36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23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2485" y="4539029"/>
            <a:ext cx="5153030" cy="36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0288714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6</TotalTime>
  <Words>124</Words>
  <Application>Microsoft Office PowerPoint</Application>
  <PresentationFormat>Affichage à l'écran (4:3)</PresentationFormat>
  <Paragraphs>8</Paragraphs>
  <Slides>7</Slides>
  <Notes>1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7</vt:i4>
      </vt:variant>
    </vt:vector>
  </HeadingPairs>
  <TitlesOfParts>
    <vt:vector size="8" baseType="lpstr"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dmin</dc:creator>
  <cp:lastModifiedBy>Admin</cp:lastModifiedBy>
  <cp:revision>11</cp:revision>
  <cp:lastPrinted>2015-02-19T15:17:55Z</cp:lastPrinted>
  <dcterms:created xsi:type="dcterms:W3CDTF">2015-02-18T16:32:58Z</dcterms:created>
  <dcterms:modified xsi:type="dcterms:W3CDTF">2015-02-19T15:27:55Z</dcterms:modified>
</cp:coreProperties>
</file>